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21674138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6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26" d="100"/>
          <a:sy n="26" d="100"/>
        </p:scale>
        <p:origin x="3870" y="8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47135"/>
            <a:ext cx="10363200" cy="75458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83941"/>
            <a:ext cx="9144000" cy="523289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05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5291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53947"/>
            <a:ext cx="2628900" cy="183678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53947"/>
            <a:ext cx="7734300" cy="183678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658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8498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403489"/>
            <a:ext cx="10515600" cy="90158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504620"/>
            <a:ext cx="10515600" cy="474121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2429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48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53952"/>
            <a:ext cx="10515600" cy="418933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313176"/>
            <a:ext cx="5157787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917081"/>
            <a:ext cx="5157787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313176"/>
            <a:ext cx="5183188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917081"/>
            <a:ext cx="5183188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20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673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192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20679"/>
            <a:ext cx="6172200" cy="1540268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481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20679"/>
            <a:ext cx="6172200" cy="1540268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9451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53952"/>
            <a:ext cx="105156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69736"/>
            <a:ext cx="105156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E4568-5ACD-435D-8C4D-5A025A52F662}" type="datetimeFigureOut">
              <a:rPr lang="en-GB" smtClean="0"/>
              <a:t>21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88720"/>
            <a:ext cx="41148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000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Box 90"/>
          <p:cNvSpPr txBox="1"/>
          <p:nvPr/>
        </p:nvSpPr>
        <p:spPr>
          <a:xfrm>
            <a:off x="1089162" y="1325378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083136" y="8338628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091727" y="4839823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1091727" y="12166292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1098862" y="1730281"/>
            <a:ext cx="4918929" cy="2708043"/>
            <a:chOff x="913679" y="2486487"/>
            <a:chExt cx="4918929" cy="2708043"/>
          </a:xfrm>
        </p:grpSpPr>
        <p:sp>
          <p:nvSpPr>
            <p:cNvPr id="12" name="TextBox 11"/>
            <p:cNvSpPr txBox="1"/>
            <p:nvPr/>
          </p:nvSpPr>
          <p:spPr>
            <a:xfrm>
              <a:off x="2381093" y="4689668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732850" y="46843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023005" y="46843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684610" y="46843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325107" y="46843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128342" y="3499816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464970" y="4481872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82619" y="3586756"/>
              <a:ext cx="19698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 number of cells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445138" y="4328802"/>
              <a:ext cx="1321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i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X19</a:t>
              </a:r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iRNA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423248" y="2930373"/>
              <a:ext cx="10198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</a:t>
              </a:r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reated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539210" y="4886753"/>
              <a:ext cx="11752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me (days)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116029" y="3014574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1130333" y="2536091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128342" y="4003818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423248" y="2631789"/>
              <a:ext cx="1409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  <a:endParaRPr lang="en-GB" sz="1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1854108" y="2495210"/>
              <a:ext cx="3075610" cy="2240373"/>
              <a:chOff x="3977639" y="171357"/>
              <a:chExt cx="3135619" cy="2240373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2"/>
              <a:srcRect l="17246" b="15472"/>
              <a:stretch/>
            </p:blipFill>
            <p:spPr>
              <a:xfrm>
                <a:off x="3977639" y="171357"/>
                <a:ext cx="3135619" cy="2240373"/>
              </a:xfrm>
              <a:prstGeom prst="rect">
                <a:avLst/>
              </a:prstGeom>
            </p:spPr>
          </p:pic>
          <p:sp>
            <p:nvSpPr>
              <p:cNvPr id="3" name="Rectangle 2"/>
              <p:cNvSpPr/>
              <p:nvPr/>
            </p:nvSpPr>
            <p:spPr>
              <a:xfrm>
                <a:off x="4324203" y="399957"/>
                <a:ext cx="1253871" cy="73220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88" name="TextBox 287"/>
            <p:cNvSpPr txBox="1"/>
            <p:nvPr/>
          </p:nvSpPr>
          <p:spPr>
            <a:xfrm>
              <a:off x="2064720" y="2486487"/>
              <a:ext cx="15341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W480 siRNA B</a:t>
              </a:r>
              <a:endParaRPr lang="en-GB" sz="1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6286043" y="1581038"/>
            <a:ext cx="1265129" cy="3643105"/>
            <a:chOff x="5847446" y="2412149"/>
            <a:chExt cx="1265129" cy="3643105"/>
          </a:xfrm>
        </p:grpSpPr>
        <p:sp>
          <p:nvSpPr>
            <p:cNvPr id="138" name="TextBox 137"/>
            <p:cNvSpPr txBox="1"/>
            <p:nvPr/>
          </p:nvSpPr>
          <p:spPr>
            <a:xfrm>
              <a:off x="5999197" y="2657317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6095124" y="4552469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5999197" y="3288524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 rot="-4200000">
              <a:off x="6049548" y="5155385"/>
              <a:ext cx="1321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i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X19</a:t>
              </a:r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iRNA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 rot="-4200000">
              <a:off x="5660471" y="5196685"/>
              <a:ext cx="1409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 rot="16200000">
              <a:off x="4740413" y="3519182"/>
              <a:ext cx="25218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alized fold expression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l="30424" t="22569" r="26337" b="13729"/>
            <a:stretch/>
          </p:blipFill>
          <p:spPr>
            <a:xfrm>
              <a:off x="6355543" y="2729309"/>
              <a:ext cx="757032" cy="2033734"/>
            </a:xfrm>
            <a:prstGeom prst="rect">
              <a:avLst/>
            </a:prstGeom>
          </p:spPr>
        </p:pic>
        <p:sp>
          <p:nvSpPr>
            <p:cNvPr id="113" name="TextBox 112"/>
            <p:cNvSpPr txBox="1"/>
            <p:nvPr/>
          </p:nvSpPr>
          <p:spPr>
            <a:xfrm>
              <a:off x="6014601" y="3919731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1108718" y="5251137"/>
            <a:ext cx="4795558" cy="2683489"/>
            <a:chOff x="6967932" y="2508577"/>
            <a:chExt cx="4795558" cy="2683489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/>
            <a:srcRect l="23187" t="6493" b="18746"/>
            <a:stretch/>
          </p:blipFill>
          <p:spPr>
            <a:xfrm>
              <a:off x="7888394" y="2681472"/>
              <a:ext cx="2775017" cy="2043953"/>
            </a:xfrm>
            <a:prstGeom prst="rect">
              <a:avLst/>
            </a:prstGeom>
          </p:spPr>
        </p:pic>
        <p:sp>
          <p:nvSpPr>
            <p:cNvPr id="117" name="TextBox 116"/>
            <p:cNvSpPr txBox="1"/>
            <p:nvPr/>
          </p:nvSpPr>
          <p:spPr>
            <a:xfrm>
              <a:off x="8435346" y="468720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7787103" y="4681869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9077258" y="4681869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9738863" y="4681869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0379360" y="4681869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7188214" y="3704327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7519223" y="4479408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 rot="16200000">
              <a:off x="6136872" y="3584292"/>
              <a:ext cx="19698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 number of cells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8593463" y="4884289"/>
              <a:ext cx="11752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me (days)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7189888" y="3320824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7187919" y="2940581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7189888" y="4081337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7178996" y="2574534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x10</a:t>
              </a:r>
              <a:r>
                <a:rPr lang="en-GB" sz="1400" b="1" baseline="300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10336582" y="3564481"/>
              <a:ext cx="1321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i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X19</a:t>
              </a:r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iRNA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10352978" y="3320824"/>
              <a:ext cx="10198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</a:t>
              </a:r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reated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10354130" y="3084261"/>
              <a:ext cx="1409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  <a:endParaRPr lang="en-GB" sz="1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TextBox 288"/>
            <p:cNvSpPr txBox="1"/>
            <p:nvPr/>
          </p:nvSpPr>
          <p:spPr>
            <a:xfrm>
              <a:off x="8061876" y="2508577"/>
              <a:ext cx="15961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CT116 siRNA A</a:t>
              </a:r>
              <a:endParaRPr lang="en-GB" sz="14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6357695" y="5089541"/>
            <a:ext cx="1383720" cy="3643105"/>
            <a:chOff x="7361588" y="5221379"/>
            <a:chExt cx="1383720" cy="3643105"/>
          </a:xfrm>
        </p:grpSpPr>
        <p:grpSp>
          <p:nvGrpSpPr>
            <p:cNvPr id="191" name="Group 190"/>
            <p:cNvGrpSpPr/>
            <p:nvPr/>
          </p:nvGrpSpPr>
          <p:grpSpPr>
            <a:xfrm>
              <a:off x="7361588" y="5221379"/>
              <a:ext cx="1016588" cy="3643105"/>
              <a:chOff x="5847446" y="2412149"/>
              <a:chExt cx="1016588" cy="3643105"/>
            </a:xfrm>
          </p:grpSpPr>
          <p:sp>
            <p:nvSpPr>
              <p:cNvPr id="197" name="TextBox 196"/>
              <p:cNvSpPr txBox="1"/>
              <p:nvPr/>
            </p:nvSpPr>
            <p:spPr>
              <a:xfrm>
                <a:off x="5999197" y="2657317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6095124" y="45524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5999197" y="3288524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TextBox 201"/>
              <p:cNvSpPr txBox="1"/>
              <p:nvPr/>
            </p:nvSpPr>
            <p:spPr>
              <a:xfrm rot="-4200000">
                <a:off x="6049548" y="5155385"/>
                <a:ext cx="13211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i="1" dirty="0" smtClean="0">
                    <a:solidFill>
                      <a:srgbClr val="96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X19</a:t>
                </a:r>
                <a:r>
                  <a:rPr lang="en-GB" sz="1400" b="1" dirty="0" smtClean="0">
                    <a:solidFill>
                      <a:srgbClr val="96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siRNA</a:t>
                </a:r>
                <a:endParaRPr lang="en-GB" sz="1400" b="1" dirty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 rot="-4200000">
                <a:off x="5660471" y="5196685"/>
                <a:ext cx="14093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 siRNA</a:t>
                </a:r>
                <a:endParaRPr lang="en-GB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 rot="16200000">
                <a:off x="4740413" y="3519182"/>
                <a:ext cx="25218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rmalized fold expression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>
                <a:off x="6014601" y="3919731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5"/>
            <a:srcRect l="48379" t="18539" b="17529"/>
            <a:stretch/>
          </p:blipFill>
          <p:spPr>
            <a:xfrm>
              <a:off x="7879293" y="5523305"/>
              <a:ext cx="866015" cy="2069432"/>
            </a:xfrm>
            <a:prstGeom prst="rect">
              <a:avLst/>
            </a:prstGeom>
          </p:spPr>
        </p:pic>
      </p:grpSp>
      <p:grpSp>
        <p:nvGrpSpPr>
          <p:cNvPr id="66" name="Group 65"/>
          <p:cNvGrpSpPr/>
          <p:nvPr/>
        </p:nvGrpSpPr>
        <p:grpSpPr>
          <a:xfrm>
            <a:off x="1110716" y="8884340"/>
            <a:ext cx="4989074" cy="2710347"/>
            <a:chOff x="2134839" y="8918399"/>
            <a:chExt cx="4989074" cy="2710347"/>
          </a:xfrm>
        </p:grpSpPr>
        <p:grpSp>
          <p:nvGrpSpPr>
            <p:cNvPr id="224" name="Group 223"/>
            <p:cNvGrpSpPr/>
            <p:nvPr/>
          </p:nvGrpSpPr>
          <p:grpSpPr>
            <a:xfrm>
              <a:off x="2134839" y="8918399"/>
              <a:ext cx="4989074" cy="2710347"/>
              <a:chOff x="6967932" y="2481719"/>
              <a:chExt cx="4989074" cy="2710347"/>
            </a:xfrm>
          </p:grpSpPr>
          <p:sp>
            <p:nvSpPr>
              <p:cNvPr id="226" name="TextBox 225"/>
              <p:cNvSpPr txBox="1"/>
              <p:nvPr/>
            </p:nvSpPr>
            <p:spPr>
              <a:xfrm>
                <a:off x="8435346" y="4687204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7787103" y="46818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9077258" y="46818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TextBox 228"/>
              <p:cNvSpPr txBox="1"/>
              <p:nvPr/>
            </p:nvSpPr>
            <p:spPr>
              <a:xfrm>
                <a:off x="9738863" y="46818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10379360" y="46818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7151024" y="3535455"/>
                <a:ext cx="7986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.0x10</a:t>
                </a:r>
                <a:r>
                  <a:rPr lang="en-GB" sz="1400" b="1" baseline="30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baseline="300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7492993" y="4480464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 rot="16200000">
                <a:off x="6136872" y="3584292"/>
                <a:ext cx="19698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al number of cells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8593463" y="4884289"/>
                <a:ext cx="11752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 (days)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TextBox 234"/>
              <p:cNvSpPr txBox="1"/>
              <p:nvPr/>
            </p:nvSpPr>
            <p:spPr>
              <a:xfrm>
                <a:off x="7177589" y="3037089"/>
                <a:ext cx="7986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.0x10</a:t>
                </a:r>
                <a:r>
                  <a:rPr lang="en-GB" sz="1400" b="1" baseline="30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baseline="300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TextBox 235"/>
              <p:cNvSpPr txBox="1"/>
              <p:nvPr/>
            </p:nvSpPr>
            <p:spPr>
              <a:xfrm>
                <a:off x="7167767" y="2590446"/>
                <a:ext cx="7986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.0x10</a:t>
                </a:r>
                <a:r>
                  <a:rPr lang="en-GB" sz="1400" b="1" baseline="30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baseline="300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TextBox 236"/>
              <p:cNvSpPr txBox="1"/>
              <p:nvPr/>
            </p:nvSpPr>
            <p:spPr>
              <a:xfrm>
                <a:off x="7151024" y="4009605"/>
                <a:ext cx="7986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0x10</a:t>
                </a:r>
                <a:r>
                  <a:rPr lang="en-GB" sz="1400" b="1" baseline="30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baseline="300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10526957" y="4164777"/>
                <a:ext cx="13211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i="1" dirty="0" smtClean="0">
                    <a:solidFill>
                      <a:srgbClr val="96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X19</a:t>
                </a:r>
                <a:r>
                  <a:rPr lang="en-GB" sz="1400" b="1" dirty="0" smtClean="0">
                    <a:solidFill>
                      <a:srgbClr val="96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siRNA</a:t>
                </a:r>
                <a:endParaRPr lang="en-GB" sz="1400" b="1" dirty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TextBox 239"/>
              <p:cNvSpPr txBox="1"/>
              <p:nvPr/>
            </p:nvSpPr>
            <p:spPr>
              <a:xfrm>
                <a:off x="10544105" y="3273502"/>
                <a:ext cx="101983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GB" sz="1400" b="1" dirty="0" smtClean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treated</a:t>
                </a:r>
                <a:endParaRPr lang="en-GB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>
                <a:off x="10547646" y="2926742"/>
                <a:ext cx="14093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 siRNA</a:t>
                </a:r>
                <a:endParaRPr lang="en-GB" sz="1400" b="1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TextBox 290"/>
              <p:cNvSpPr txBox="1"/>
              <p:nvPr/>
            </p:nvSpPr>
            <p:spPr>
              <a:xfrm>
                <a:off x="8139331" y="2481719"/>
                <a:ext cx="136716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460 siRNA A</a:t>
                </a:r>
                <a:endParaRPr lang="en-GB" sz="1400" b="1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3057376" y="9011215"/>
              <a:ext cx="2899610" cy="2157550"/>
              <a:chOff x="8181474" y="8975558"/>
              <a:chExt cx="2899610" cy="2093495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6"/>
              <a:srcRect l="17543" t="2577" r="6079" b="15818"/>
              <a:stretch/>
            </p:blipFill>
            <p:spPr>
              <a:xfrm>
                <a:off x="8181474" y="8975558"/>
                <a:ext cx="2899610" cy="2093495"/>
              </a:xfrm>
              <a:prstGeom prst="rect">
                <a:avLst/>
              </a:prstGeom>
            </p:spPr>
          </p:pic>
          <p:sp>
            <p:nvSpPr>
              <p:cNvPr id="17" name="Rectangle 16"/>
              <p:cNvSpPr/>
              <p:nvPr/>
            </p:nvSpPr>
            <p:spPr>
              <a:xfrm>
                <a:off x="8482263" y="9165102"/>
                <a:ext cx="1263316" cy="6636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grpSp>
        <p:nvGrpSpPr>
          <p:cNvPr id="30" name="Group 29"/>
          <p:cNvGrpSpPr/>
          <p:nvPr/>
        </p:nvGrpSpPr>
        <p:grpSpPr>
          <a:xfrm>
            <a:off x="6440323" y="8740611"/>
            <a:ext cx="1362166" cy="3643105"/>
            <a:chOff x="7357970" y="8855543"/>
            <a:chExt cx="1362166" cy="3643105"/>
          </a:xfrm>
        </p:grpSpPr>
        <p:grpSp>
          <p:nvGrpSpPr>
            <p:cNvPr id="269" name="Group 268"/>
            <p:cNvGrpSpPr/>
            <p:nvPr/>
          </p:nvGrpSpPr>
          <p:grpSpPr>
            <a:xfrm>
              <a:off x="7357970" y="8855543"/>
              <a:ext cx="1016588" cy="3643105"/>
              <a:chOff x="5847446" y="2412149"/>
              <a:chExt cx="1016588" cy="3643105"/>
            </a:xfrm>
          </p:grpSpPr>
          <p:sp>
            <p:nvSpPr>
              <p:cNvPr id="271" name="TextBox 270"/>
              <p:cNvSpPr txBox="1"/>
              <p:nvPr/>
            </p:nvSpPr>
            <p:spPr>
              <a:xfrm>
                <a:off x="5999197" y="2657317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>
                <a:off x="6095124" y="45524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>
                <a:off x="5999197" y="3288524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 rot="-4200000">
                <a:off x="6049548" y="5155385"/>
                <a:ext cx="13211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i="1" dirty="0" smtClean="0">
                    <a:solidFill>
                      <a:srgbClr val="96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X19</a:t>
                </a:r>
                <a:r>
                  <a:rPr lang="en-GB" sz="1400" b="1" dirty="0" smtClean="0">
                    <a:solidFill>
                      <a:srgbClr val="96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siRNA</a:t>
                </a:r>
                <a:endParaRPr lang="en-GB" sz="1400" b="1" dirty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TextBox 274"/>
              <p:cNvSpPr txBox="1"/>
              <p:nvPr/>
            </p:nvSpPr>
            <p:spPr>
              <a:xfrm rot="-4200000">
                <a:off x="5660471" y="5196685"/>
                <a:ext cx="14093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 siRNA</a:t>
                </a:r>
                <a:endParaRPr lang="en-GB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 rot="16200000">
                <a:off x="4740413" y="3519182"/>
                <a:ext cx="25218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rmalized fold expression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TextBox 276"/>
              <p:cNvSpPr txBox="1"/>
              <p:nvPr/>
            </p:nvSpPr>
            <p:spPr>
              <a:xfrm>
                <a:off x="6014601" y="3919731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7"/>
            <a:srcRect l="35101" t="16942" r="11109" b="19391"/>
            <a:stretch/>
          </p:blipFill>
          <p:spPr>
            <a:xfrm>
              <a:off x="7874633" y="9093977"/>
              <a:ext cx="845503" cy="2161766"/>
            </a:xfrm>
            <a:prstGeom prst="rect">
              <a:avLst/>
            </a:prstGeom>
          </p:spPr>
        </p:pic>
      </p:grpSp>
      <p:grpSp>
        <p:nvGrpSpPr>
          <p:cNvPr id="64" name="Group 63"/>
          <p:cNvGrpSpPr/>
          <p:nvPr/>
        </p:nvGrpSpPr>
        <p:grpSpPr>
          <a:xfrm>
            <a:off x="1108718" y="12612522"/>
            <a:ext cx="5047743" cy="2629476"/>
            <a:chOff x="2130050" y="12887943"/>
            <a:chExt cx="5047743" cy="2629476"/>
          </a:xfrm>
        </p:grpSpPr>
        <p:grpSp>
          <p:nvGrpSpPr>
            <p:cNvPr id="242" name="Group 241"/>
            <p:cNvGrpSpPr/>
            <p:nvPr/>
          </p:nvGrpSpPr>
          <p:grpSpPr>
            <a:xfrm>
              <a:off x="2130050" y="12887943"/>
              <a:ext cx="5047743" cy="2629476"/>
              <a:chOff x="6967932" y="2562590"/>
              <a:chExt cx="5047743" cy="2629476"/>
            </a:xfrm>
          </p:grpSpPr>
          <p:sp>
            <p:nvSpPr>
              <p:cNvPr id="244" name="TextBox 243"/>
              <p:cNvSpPr txBox="1"/>
              <p:nvPr/>
            </p:nvSpPr>
            <p:spPr>
              <a:xfrm>
                <a:off x="8435346" y="4687204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7787103" y="46818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TextBox 245"/>
              <p:cNvSpPr txBox="1"/>
              <p:nvPr/>
            </p:nvSpPr>
            <p:spPr>
              <a:xfrm>
                <a:off x="9077258" y="46818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TextBox 246"/>
              <p:cNvSpPr txBox="1"/>
              <p:nvPr/>
            </p:nvSpPr>
            <p:spPr>
              <a:xfrm>
                <a:off x="9738863" y="46818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10379360" y="4681869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TextBox 248"/>
              <p:cNvSpPr txBox="1"/>
              <p:nvPr/>
            </p:nvSpPr>
            <p:spPr>
              <a:xfrm>
                <a:off x="7172554" y="3598280"/>
                <a:ext cx="7986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.0x10</a:t>
                </a:r>
                <a:r>
                  <a:rPr lang="en-GB" sz="1400" b="1" baseline="30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baseline="300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TextBox 249"/>
              <p:cNvSpPr txBox="1"/>
              <p:nvPr/>
            </p:nvSpPr>
            <p:spPr>
              <a:xfrm>
                <a:off x="7502842" y="4527980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TextBox 250"/>
              <p:cNvSpPr txBox="1"/>
              <p:nvPr/>
            </p:nvSpPr>
            <p:spPr>
              <a:xfrm rot="16200000">
                <a:off x="6136872" y="3584292"/>
                <a:ext cx="19698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al number of cells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TextBox 251"/>
              <p:cNvSpPr txBox="1"/>
              <p:nvPr/>
            </p:nvSpPr>
            <p:spPr>
              <a:xfrm>
                <a:off x="8593463" y="4884289"/>
                <a:ext cx="11752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 (days)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7190916" y="3108382"/>
                <a:ext cx="7986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.0x10</a:t>
                </a:r>
                <a:r>
                  <a:rPr lang="en-GB" sz="1400" b="1" baseline="30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baseline="300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7172555" y="2660285"/>
                <a:ext cx="7986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.0x10</a:t>
                </a:r>
                <a:r>
                  <a:rPr lang="en-GB" sz="1400" b="1" baseline="30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baseline="300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7178996" y="4055520"/>
                <a:ext cx="7986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0x10</a:t>
                </a:r>
                <a:r>
                  <a:rPr lang="en-GB" sz="1400" b="1" baseline="30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400" b="1" baseline="300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10624105" y="4479407"/>
                <a:ext cx="13211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i="1" dirty="0" smtClean="0">
                    <a:solidFill>
                      <a:srgbClr val="96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X19</a:t>
                </a:r>
                <a:r>
                  <a:rPr lang="en-GB" sz="1400" b="1" dirty="0" smtClean="0">
                    <a:solidFill>
                      <a:srgbClr val="96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siRNA</a:t>
                </a:r>
                <a:endParaRPr lang="en-GB" sz="1400" b="1" dirty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TextBox 257"/>
              <p:cNvSpPr txBox="1"/>
              <p:nvPr/>
            </p:nvSpPr>
            <p:spPr>
              <a:xfrm>
                <a:off x="10606315" y="3415613"/>
                <a:ext cx="101983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GB" sz="1400" b="1" dirty="0" smtClean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treated</a:t>
                </a:r>
                <a:endParaRPr lang="en-GB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TextBox 258"/>
              <p:cNvSpPr txBox="1"/>
              <p:nvPr/>
            </p:nvSpPr>
            <p:spPr>
              <a:xfrm>
                <a:off x="10606315" y="3113079"/>
                <a:ext cx="14093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 siRNA</a:t>
                </a:r>
                <a:endParaRPr lang="en-GB" sz="1400" b="1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TextBox 291"/>
              <p:cNvSpPr txBox="1"/>
              <p:nvPr/>
            </p:nvSpPr>
            <p:spPr>
              <a:xfrm>
                <a:off x="8011938" y="2562590"/>
                <a:ext cx="16639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TERA2 siRNA B</a:t>
                </a:r>
                <a:endParaRPr lang="en-GB" sz="1400" b="1" dirty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3070624" y="13036497"/>
              <a:ext cx="2828470" cy="2057034"/>
              <a:chOff x="7638881" y="13289913"/>
              <a:chExt cx="3383277" cy="2141621"/>
            </a:xfrm>
          </p:grpSpPr>
          <p:pic>
            <p:nvPicPr>
              <p:cNvPr id="26" name="Picture 25"/>
              <p:cNvPicPr>
                <a:picLocks noChangeAspect="1"/>
              </p:cNvPicPr>
              <p:nvPr/>
            </p:nvPicPr>
            <p:blipFill rotWithShape="1">
              <a:blip r:embed="rId8"/>
              <a:srcRect l="18200" t="4611" r="6908" b="15260"/>
              <a:stretch/>
            </p:blipFill>
            <p:spPr>
              <a:xfrm>
                <a:off x="7638881" y="13289913"/>
                <a:ext cx="3383277" cy="2141621"/>
              </a:xfrm>
              <a:prstGeom prst="rect">
                <a:avLst/>
              </a:prstGeom>
            </p:spPr>
          </p:pic>
          <p:sp>
            <p:nvSpPr>
              <p:cNvPr id="27" name="Rectangle 26"/>
              <p:cNvSpPr/>
              <p:nvPr/>
            </p:nvSpPr>
            <p:spPr>
              <a:xfrm>
                <a:off x="8027299" y="13563502"/>
                <a:ext cx="1480843" cy="62006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grpSp>
        <p:nvGrpSpPr>
          <p:cNvPr id="69" name="Group 68"/>
          <p:cNvGrpSpPr/>
          <p:nvPr/>
        </p:nvGrpSpPr>
        <p:grpSpPr>
          <a:xfrm>
            <a:off x="6497603" y="12455346"/>
            <a:ext cx="1395265" cy="3643105"/>
            <a:chOff x="7348953" y="12646535"/>
            <a:chExt cx="1395265" cy="3643105"/>
          </a:xfrm>
        </p:grpSpPr>
        <p:sp>
          <p:nvSpPr>
            <p:cNvPr id="281" name="TextBox 280"/>
            <p:cNvSpPr txBox="1"/>
            <p:nvPr/>
          </p:nvSpPr>
          <p:spPr>
            <a:xfrm>
              <a:off x="7500704" y="12891703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TextBox 281"/>
            <p:cNvSpPr txBox="1"/>
            <p:nvPr/>
          </p:nvSpPr>
          <p:spPr>
            <a:xfrm>
              <a:off x="7596631" y="14786855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TextBox 282"/>
            <p:cNvSpPr txBox="1"/>
            <p:nvPr/>
          </p:nvSpPr>
          <p:spPr>
            <a:xfrm>
              <a:off x="7500704" y="13522910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TextBox 283"/>
            <p:cNvSpPr txBox="1"/>
            <p:nvPr/>
          </p:nvSpPr>
          <p:spPr>
            <a:xfrm rot="17400000">
              <a:off x="7551055" y="15389771"/>
              <a:ext cx="1321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i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X19</a:t>
              </a:r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iRNA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TextBox 284"/>
            <p:cNvSpPr txBox="1"/>
            <p:nvPr/>
          </p:nvSpPr>
          <p:spPr>
            <a:xfrm rot="17400000">
              <a:off x="7161978" y="15431071"/>
              <a:ext cx="1409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TextBox 285"/>
            <p:cNvSpPr txBox="1"/>
            <p:nvPr/>
          </p:nvSpPr>
          <p:spPr>
            <a:xfrm rot="16200000">
              <a:off x="6241920" y="13753568"/>
              <a:ext cx="25218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alized fold expression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TextBox 286"/>
            <p:cNvSpPr txBox="1"/>
            <p:nvPr/>
          </p:nvSpPr>
          <p:spPr>
            <a:xfrm>
              <a:off x="7516108" y="14154117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9"/>
            <a:srcRect l="30044" t="17309" r="23054" b="18856"/>
            <a:stretch/>
          </p:blipFill>
          <p:spPr>
            <a:xfrm>
              <a:off x="7873164" y="12907630"/>
              <a:ext cx="871054" cy="2120113"/>
            </a:xfrm>
            <a:prstGeom prst="rect">
              <a:avLst/>
            </a:prstGeom>
          </p:spPr>
        </p:pic>
      </p:grpSp>
      <p:grpSp>
        <p:nvGrpSpPr>
          <p:cNvPr id="225" name="Group 224"/>
          <p:cNvGrpSpPr/>
          <p:nvPr/>
        </p:nvGrpSpPr>
        <p:grpSpPr>
          <a:xfrm>
            <a:off x="7941759" y="1627794"/>
            <a:ext cx="3221546" cy="2063856"/>
            <a:chOff x="5724360" y="16894502"/>
            <a:chExt cx="3221546" cy="2063856"/>
          </a:xfrm>
        </p:grpSpPr>
        <p:pic>
          <p:nvPicPr>
            <p:cNvPr id="68" name="Picture 67"/>
            <p:cNvPicPr>
              <a:picLocks noChangeAspect="1"/>
            </p:cNvPicPr>
            <p:nvPr/>
          </p:nvPicPr>
          <p:blipFill rotWithShape="1">
            <a:blip r:embed="rId10"/>
            <a:srcRect l="35340" t="72665" r="30231"/>
            <a:stretch/>
          </p:blipFill>
          <p:spPr>
            <a:xfrm>
              <a:off x="6959492" y="18213454"/>
              <a:ext cx="991313" cy="744904"/>
            </a:xfrm>
            <a:prstGeom prst="rect">
              <a:avLst/>
            </a:prstGeom>
          </p:spPr>
        </p:pic>
        <p:sp>
          <p:nvSpPr>
            <p:cNvPr id="293" name="TextBox 292"/>
            <p:cNvSpPr txBox="1"/>
            <p:nvPr/>
          </p:nvSpPr>
          <p:spPr>
            <a:xfrm rot="-4200000">
              <a:off x="6725897" y="17616642"/>
              <a:ext cx="10198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TextBox 293"/>
            <p:cNvSpPr txBox="1"/>
            <p:nvPr/>
          </p:nvSpPr>
          <p:spPr>
            <a:xfrm>
              <a:off x="5724360" y="18575691"/>
              <a:ext cx="11924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Tubulin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TextBox 294"/>
            <p:cNvSpPr txBox="1"/>
            <p:nvPr/>
          </p:nvSpPr>
          <p:spPr>
            <a:xfrm>
              <a:off x="8030271" y="18236354"/>
              <a:ext cx="9156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~ 23 </a:t>
              </a:r>
              <a:r>
                <a:rPr lang="en-GB" sz="1400" b="1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TextBox 295"/>
            <p:cNvSpPr txBox="1"/>
            <p:nvPr/>
          </p:nvSpPr>
          <p:spPr>
            <a:xfrm>
              <a:off x="8030270" y="18605958"/>
              <a:ext cx="9156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~ </a:t>
              </a:r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400" b="1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TextBox 296"/>
            <p:cNvSpPr txBox="1"/>
            <p:nvPr/>
          </p:nvSpPr>
          <p:spPr>
            <a:xfrm>
              <a:off x="5732402" y="18248908"/>
              <a:ext cx="11095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i-TEX19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TextBox 297"/>
            <p:cNvSpPr txBox="1"/>
            <p:nvPr/>
          </p:nvSpPr>
          <p:spPr>
            <a:xfrm rot="-4200000">
              <a:off x="6899926" y="17445293"/>
              <a:ext cx="1409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TextBox 298"/>
            <p:cNvSpPr txBox="1"/>
            <p:nvPr/>
          </p:nvSpPr>
          <p:spPr>
            <a:xfrm rot="-4200000">
              <a:off x="7425092" y="17646563"/>
              <a:ext cx="8961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NA B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8" name="Group 237"/>
          <p:cNvGrpSpPr/>
          <p:nvPr/>
        </p:nvGrpSpPr>
        <p:grpSpPr>
          <a:xfrm>
            <a:off x="2351144" y="16040902"/>
            <a:ext cx="3116776" cy="2022084"/>
            <a:chOff x="2239071" y="16894503"/>
            <a:chExt cx="3116776" cy="2022084"/>
          </a:xfrm>
        </p:grpSpPr>
        <p:pic>
          <p:nvPicPr>
            <p:cNvPr id="67" name="Picture 66"/>
            <p:cNvPicPr>
              <a:picLocks noChangeAspect="1"/>
            </p:cNvPicPr>
            <p:nvPr/>
          </p:nvPicPr>
          <p:blipFill rotWithShape="1">
            <a:blip r:embed="rId11"/>
            <a:srcRect l="33951" t="71687" r="30147"/>
            <a:stretch/>
          </p:blipFill>
          <p:spPr>
            <a:xfrm>
              <a:off x="3408310" y="18211787"/>
              <a:ext cx="954127" cy="704800"/>
            </a:xfrm>
            <a:prstGeom prst="rect">
              <a:avLst/>
            </a:prstGeom>
          </p:spPr>
        </p:pic>
        <p:sp>
          <p:nvSpPr>
            <p:cNvPr id="300" name="TextBox 299"/>
            <p:cNvSpPr txBox="1"/>
            <p:nvPr/>
          </p:nvSpPr>
          <p:spPr>
            <a:xfrm>
              <a:off x="4440212" y="18575690"/>
              <a:ext cx="9156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~ </a:t>
              </a:r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400" b="1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TextBox 300"/>
            <p:cNvSpPr txBox="1"/>
            <p:nvPr/>
          </p:nvSpPr>
          <p:spPr>
            <a:xfrm>
              <a:off x="4440211" y="18256410"/>
              <a:ext cx="9156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~ 23 </a:t>
              </a:r>
              <a:r>
                <a:rPr lang="en-GB" sz="1400" b="1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TextBox 301"/>
            <p:cNvSpPr txBox="1"/>
            <p:nvPr/>
          </p:nvSpPr>
          <p:spPr>
            <a:xfrm>
              <a:off x="2243715" y="18248907"/>
              <a:ext cx="11095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i-TEX19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TextBox 302"/>
            <p:cNvSpPr txBox="1"/>
            <p:nvPr/>
          </p:nvSpPr>
          <p:spPr>
            <a:xfrm>
              <a:off x="2239071" y="18575689"/>
              <a:ext cx="11924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Tubulin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TextBox 303"/>
            <p:cNvSpPr txBox="1"/>
            <p:nvPr/>
          </p:nvSpPr>
          <p:spPr>
            <a:xfrm rot="-4200000">
              <a:off x="3155395" y="17616643"/>
              <a:ext cx="10198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TextBox 304"/>
            <p:cNvSpPr txBox="1"/>
            <p:nvPr/>
          </p:nvSpPr>
          <p:spPr>
            <a:xfrm rot="-4200000">
              <a:off x="3329424" y="17445294"/>
              <a:ext cx="1409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 siRNA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TextBox 305"/>
            <p:cNvSpPr txBox="1"/>
            <p:nvPr/>
          </p:nvSpPr>
          <p:spPr>
            <a:xfrm rot="-4200000">
              <a:off x="3854590" y="17646564"/>
              <a:ext cx="8961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NA A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7" name="TextBox 306"/>
          <p:cNvSpPr txBox="1"/>
          <p:nvPr/>
        </p:nvSpPr>
        <p:spPr>
          <a:xfrm>
            <a:off x="2327359" y="16088335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TextBox 242"/>
          <p:cNvSpPr txBox="1"/>
          <p:nvPr/>
        </p:nvSpPr>
        <p:spPr>
          <a:xfrm>
            <a:off x="9305647" y="6227791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endParaRPr lang="en-GB" b="1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2" name="Group 261"/>
          <p:cNvGrpSpPr/>
          <p:nvPr/>
        </p:nvGrpSpPr>
        <p:grpSpPr>
          <a:xfrm>
            <a:off x="7943051" y="8616624"/>
            <a:ext cx="3221546" cy="2019233"/>
            <a:chOff x="7875505" y="12224880"/>
            <a:chExt cx="3221546" cy="2019233"/>
          </a:xfrm>
        </p:grpSpPr>
        <p:grpSp>
          <p:nvGrpSpPr>
            <p:cNvPr id="156" name="Group 155"/>
            <p:cNvGrpSpPr/>
            <p:nvPr/>
          </p:nvGrpSpPr>
          <p:grpSpPr>
            <a:xfrm>
              <a:off x="7875505" y="12224880"/>
              <a:ext cx="3221546" cy="2019233"/>
              <a:chOff x="5724360" y="16894502"/>
              <a:chExt cx="3221546" cy="2019233"/>
            </a:xfrm>
          </p:grpSpPr>
          <p:sp>
            <p:nvSpPr>
              <p:cNvPr id="159" name="TextBox 158"/>
              <p:cNvSpPr txBox="1"/>
              <p:nvPr/>
            </p:nvSpPr>
            <p:spPr>
              <a:xfrm rot="-4200000">
                <a:off x="6725897" y="17616642"/>
                <a:ext cx="101983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ntreated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5724360" y="18575691"/>
                <a:ext cx="119244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ti-Tubulin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>
                <a:off x="8030271" y="18236354"/>
                <a:ext cx="91563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~ 23 </a:t>
                </a:r>
                <a:r>
                  <a:rPr lang="en-GB" sz="1400" b="1" dirty="0" err="1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8030270" y="18605958"/>
                <a:ext cx="91563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~ </a:t>
                </a:r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400" b="1" dirty="0" err="1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5732402" y="18248908"/>
                <a:ext cx="11095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ti-TEX19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 rot="-4200000">
                <a:off x="6899926" y="17445293"/>
                <a:ext cx="14093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 siRNA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 rot="-4200000">
                <a:off x="7425092" y="17646563"/>
                <a:ext cx="8961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RNA B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1" name="Group 260"/>
            <p:cNvGrpSpPr/>
            <p:nvPr/>
          </p:nvGrpSpPr>
          <p:grpSpPr>
            <a:xfrm>
              <a:off x="9129071" y="13585156"/>
              <a:ext cx="977543" cy="603814"/>
              <a:chOff x="9726451" y="13604513"/>
              <a:chExt cx="977543" cy="603814"/>
            </a:xfrm>
          </p:grpSpPr>
          <p:pic>
            <p:nvPicPr>
              <p:cNvPr id="256" name="Picture 255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9729028" y="13604513"/>
                <a:ext cx="974966" cy="287890"/>
              </a:xfrm>
              <a:prstGeom prst="rect">
                <a:avLst/>
              </a:prstGeom>
            </p:spPr>
          </p:pic>
          <p:pic>
            <p:nvPicPr>
              <p:cNvPr id="260" name="Picture 259"/>
              <p:cNvPicPr>
                <a:picLocks noChangeAspect="1"/>
              </p:cNvPicPr>
              <p:nvPr/>
            </p:nvPicPr>
            <p:blipFill rotWithShape="1">
              <a:blip r:embed="rId13"/>
              <a:srcRect r="1460"/>
              <a:stretch/>
            </p:blipFill>
            <p:spPr>
              <a:xfrm>
                <a:off x="9726451" y="13911587"/>
                <a:ext cx="977543" cy="296740"/>
              </a:xfrm>
              <a:prstGeom prst="rect">
                <a:avLst/>
              </a:prstGeom>
            </p:spPr>
          </p:pic>
        </p:grpSp>
      </p:grpSp>
      <p:grpSp>
        <p:nvGrpSpPr>
          <p:cNvPr id="266" name="Group 265"/>
          <p:cNvGrpSpPr/>
          <p:nvPr/>
        </p:nvGrpSpPr>
        <p:grpSpPr>
          <a:xfrm>
            <a:off x="7941760" y="12240107"/>
            <a:ext cx="3221546" cy="2019233"/>
            <a:chOff x="8139584" y="12272546"/>
            <a:chExt cx="3221546" cy="2019233"/>
          </a:xfrm>
        </p:grpSpPr>
        <p:grpSp>
          <p:nvGrpSpPr>
            <p:cNvPr id="145" name="Group 144"/>
            <p:cNvGrpSpPr/>
            <p:nvPr/>
          </p:nvGrpSpPr>
          <p:grpSpPr>
            <a:xfrm>
              <a:off x="8139584" y="12272546"/>
              <a:ext cx="3221546" cy="2019233"/>
              <a:chOff x="5724360" y="16894502"/>
              <a:chExt cx="3221546" cy="2019233"/>
            </a:xfrm>
          </p:grpSpPr>
          <p:sp>
            <p:nvSpPr>
              <p:cNvPr id="149" name="TextBox 148"/>
              <p:cNvSpPr txBox="1"/>
              <p:nvPr/>
            </p:nvSpPr>
            <p:spPr>
              <a:xfrm rot="-4200000">
                <a:off x="6725897" y="17616642"/>
                <a:ext cx="101983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ntreated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5724360" y="18575691"/>
                <a:ext cx="119244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ti-Tubulin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>
                <a:off x="8030271" y="18236354"/>
                <a:ext cx="91563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~ 23 </a:t>
                </a:r>
                <a:r>
                  <a:rPr lang="en-GB" sz="1400" b="1" dirty="0" err="1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8030270" y="18605958"/>
                <a:ext cx="91563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~ </a:t>
                </a:r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400" b="1" dirty="0" err="1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5732402" y="18248908"/>
                <a:ext cx="11095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ti-TEX19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 rot="-4200000">
                <a:off x="6899926" y="17445293"/>
                <a:ext cx="14093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 siRNA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TextBox 154"/>
              <p:cNvSpPr txBox="1"/>
              <p:nvPr/>
            </p:nvSpPr>
            <p:spPr>
              <a:xfrm rot="17400000">
                <a:off x="7428426" y="17646563"/>
                <a:ext cx="88947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RNA </a:t>
                </a:r>
                <a:r>
                  <a:rPr lang="en-GB" sz="1400" b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5" name="Group 264"/>
            <p:cNvGrpSpPr/>
            <p:nvPr/>
          </p:nvGrpSpPr>
          <p:grpSpPr>
            <a:xfrm>
              <a:off x="9372068" y="13654425"/>
              <a:ext cx="993961" cy="617006"/>
              <a:chOff x="9372068" y="13701820"/>
              <a:chExt cx="993961" cy="617006"/>
            </a:xfrm>
          </p:grpSpPr>
          <p:pic>
            <p:nvPicPr>
              <p:cNvPr id="263" name="Picture 262"/>
              <p:cNvPicPr>
                <a:picLocks noChangeAspect="1"/>
              </p:cNvPicPr>
              <p:nvPr/>
            </p:nvPicPr>
            <p:blipFill rotWithShape="1">
              <a:blip r:embed="rId14"/>
              <a:srcRect r="2826"/>
              <a:stretch/>
            </p:blipFill>
            <p:spPr>
              <a:xfrm>
                <a:off x="9372068" y="13701820"/>
                <a:ext cx="988891" cy="308012"/>
              </a:xfrm>
              <a:prstGeom prst="rect">
                <a:avLst/>
              </a:prstGeom>
            </p:spPr>
          </p:pic>
          <p:pic>
            <p:nvPicPr>
              <p:cNvPr id="264" name="Picture 263"/>
              <p:cNvPicPr>
                <a:picLocks noChangeAspect="1"/>
              </p:cNvPicPr>
              <p:nvPr/>
            </p:nvPicPr>
            <p:blipFill rotWithShape="1">
              <a:blip r:embed="rId15"/>
              <a:srcRect t="39306"/>
              <a:stretch/>
            </p:blipFill>
            <p:spPr>
              <a:xfrm>
                <a:off x="9374715" y="14037825"/>
                <a:ext cx="991314" cy="281001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652851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2</TotalTime>
  <Words>207</Words>
  <Application>Microsoft Office PowerPoint</Application>
  <PresentationFormat>Custom</PresentationFormat>
  <Paragraphs>1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Pryfysgol Bangor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say McFarlane</dc:creator>
  <cp:lastModifiedBy>Ramsay McFarlane</cp:lastModifiedBy>
  <cp:revision>52</cp:revision>
  <cp:lastPrinted>2017-02-21T12:09:27Z</cp:lastPrinted>
  <dcterms:created xsi:type="dcterms:W3CDTF">2016-08-11T08:24:58Z</dcterms:created>
  <dcterms:modified xsi:type="dcterms:W3CDTF">2017-02-21T13:20:34Z</dcterms:modified>
</cp:coreProperties>
</file>